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7"/>
  </p:notesMasterIdLst>
  <p:sldIdLst>
    <p:sldId id="260" r:id="rId2"/>
    <p:sldId id="261" r:id="rId3"/>
    <p:sldId id="262" r:id="rId4"/>
    <p:sldId id="268" r:id="rId5"/>
    <p:sldId id="269" r:id="rId6"/>
  </p:sldIdLst>
  <p:sldSz cx="6858000" cy="96012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32" userDrawn="1">
          <p15:clr>
            <a:srgbClr val="A4A3A4"/>
          </p15:clr>
        </p15:guide>
        <p15:guide id="2" pos="216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221" autoAdjust="0"/>
    <p:restoredTop sz="86395"/>
  </p:normalViewPr>
  <p:slideViewPr>
    <p:cSldViewPr snapToGrid="0">
      <p:cViewPr varScale="1">
        <p:scale>
          <a:sx n="75" d="100"/>
          <a:sy n="75" d="100"/>
        </p:scale>
        <p:origin x="4664" y="176"/>
      </p:cViewPr>
      <p:guideLst>
        <p:guide orient="horz" pos="4632"/>
        <p:guide pos="21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>
      <p:cViewPr varScale="1">
        <p:scale>
          <a:sx n="95" d="100"/>
          <a:sy n="95" d="100"/>
        </p:scale>
        <p:origin x="4320" y="20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FDACEF-140A-0541-B5F6-17825C722D92}" type="datetimeFigureOut">
              <a:rPr lang="en-US" smtClean="0"/>
              <a:t>7/23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84425" y="1162050"/>
            <a:ext cx="224155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BE4691-32B6-F04A-B757-09141F4BF9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1611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BE4691-32B6-F04A-B757-09141F4BF9D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8252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BE4691-32B6-F04A-B757-09141F4BF9D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6919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571308"/>
            <a:ext cx="5829300" cy="334264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042853"/>
            <a:ext cx="5143500" cy="231806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7526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046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11175"/>
            <a:ext cx="1478756" cy="813657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11175"/>
            <a:ext cx="4350544" cy="813657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575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464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393635"/>
            <a:ext cx="5915025" cy="39938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425250"/>
            <a:ext cx="5915025" cy="210026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05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555875"/>
            <a:ext cx="2914650" cy="60918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555875"/>
            <a:ext cx="2914650" cy="60918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019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11177"/>
            <a:ext cx="5915025" cy="18557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353628"/>
            <a:ext cx="2901255" cy="11534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507105"/>
            <a:ext cx="2901255" cy="515842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353628"/>
            <a:ext cx="2915543" cy="115347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507105"/>
            <a:ext cx="2915543" cy="515842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07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279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5304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0080"/>
            <a:ext cx="2211884" cy="22402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82397"/>
            <a:ext cx="3471863" cy="682307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880360"/>
            <a:ext cx="2211884" cy="53362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117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0080"/>
            <a:ext cx="2211884" cy="22402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82397"/>
            <a:ext cx="3471863" cy="682307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880360"/>
            <a:ext cx="2211884" cy="53362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6856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11177"/>
            <a:ext cx="5915025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555875"/>
            <a:ext cx="5915025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898892"/>
            <a:ext cx="154305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20625-1441-41D2-8DB5-FDA7CA4388B3}" type="datetimeFigureOut">
              <a:rPr lang="en-US" smtClean="0"/>
              <a:t>7/2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898892"/>
            <a:ext cx="2314575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898892"/>
            <a:ext cx="154305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1F032-7D3F-4AE3-ADC7-58D474833E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9111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emf"/><Relationship Id="rId4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19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18.png"/><Relationship Id="rId4" Type="http://schemas.openxmlformats.org/officeDocument/2006/relationships/image" Target="../media/image15.png"/><Relationship Id="rId9" Type="http://schemas.microsoft.com/office/2007/relationships/hdphoto" Target="../media/hdphoto4.wdp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4C64DE5-BB51-4DE7-8F6A-C7367EEDA7BB}"/>
              </a:ext>
            </a:extLst>
          </p:cNvPr>
          <p:cNvSpPr txBox="1"/>
          <p:nvPr/>
        </p:nvSpPr>
        <p:spPr>
          <a:xfrm>
            <a:off x="179610" y="457327"/>
            <a:ext cx="2562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5F49791-D465-421F-99BE-5EAC41B518F2}"/>
              </a:ext>
            </a:extLst>
          </p:cNvPr>
          <p:cNvSpPr txBox="1"/>
          <p:nvPr/>
        </p:nvSpPr>
        <p:spPr>
          <a:xfrm>
            <a:off x="125798" y="8442405"/>
            <a:ext cx="658021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1. A-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The number of neutrophils (CD11b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y6G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and inflammatory monocytes (CD11b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Ly6C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determined by FACS in peritoneal lavage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n=10-12/group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otal white blood cell (WBC) counts by complete blood cell count (CBCC) analysis in peripheral blood in 7 months after treatment. n=4-6 per group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-E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Inflammatory cytokines (S100A8/9 and MCP-1) in peritoneal lavage by ELISA. n=10-12/group. </a:t>
            </a:r>
            <a:r>
              <a:rPr lang="en-US" sz="1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ll data represent mean ± SD. Statistical significance was determined using two-Way ANOVA with </a:t>
            </a:r>
            <a:r>
              <a:rPr lang="en-US" sz="1100" dirty="0" err="1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Benferroni</a:t>
            </a:r>
            <a:r>
              <a:rPr lang="en-US" sz="1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post-hoc test . *p&lt;0.05, **p&lt;0.01, ***p&lt;0.001</a:t>
            </a:r>
            <a:endParaRPr lang="en-US" sz="11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009336D-2E3B-EC4F-B97A-866314A9F1CB}"/>
              </a:ext>
            </a:extLst>
          </p:cNvPr>
          <p:cNvSpPr txBox="1"/>
          <p:nvPr/>
        </p:nvSpPr>
        <p:spPr>
          <a:xfrm>
            <a:off x="163281" y="6044769"/>
            <a:ext cx="269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CEC8241-F29A-40D1-80D5-A4870277B680}"/>
              </a:ext>
            </a:extLst>
          </p:cNvPr>
          <p:cNvSpPr txBox="1"/>
          <p:nvPr/>
        </p:nvSpPr>
        <p:spPr>
          <a:xfrm>
            <a:off x="171428" y="3188902"/>
            <a:ext cx="2562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6CB85F5-0CC8-4834-87D3-4624CA6B553E}"/>
              </a:ext>
            </a:extLst>
          </p:cNvPr>
          <p:cNvSpPr txBox="1"/>
          <p:nvPr/>
        </p:nvSpPr>
        <p:spPr>
          <a:xfrm>
            <a:off x="3399578" y="3160880"/>
            <a:ext cx="269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57972EA-8F51-45F1-88BF-70786A5FF2FE}"/>
              </a:ext>
            </a:extLst>
          </p:cNvPr>
          <p:cNvSpPr txBox="1"/>
          <p:nvPr/>
        </p:nvSpPr>
        <p:spPr>
          <a:xfrm>
            <a:off x="3441162" y="457326"/>
            <a:ext cx="2562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4A86CF0-843D-FB42-960D-24FEAC8158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2607" y="6065064"/>
            <a:ext cx="3076688" cy="237744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B98F73D3-3902-C14E-8F2F-EE05617012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69295" y="3526297"/>
            <a:ext cx="3167909" cy="2286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20E5A76-2A63-454D-B9E7-49642925224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7743" y="3493559"/>
            <a:ext cx="3134413" cy="2286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AAACD3F-B6C8-0546-BA3A-7906CB9AE30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3283" y="774166"/>
            <a:ext cx="3240135" cy="219456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045C3267-827D-F84A-8427-DC137FBE272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93418" y="786843"/>
            <a:ext cx="3339035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98713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CE3E569-FAA6-4011-88D6-4D257BE8B683}"/>
              </a:ext>
            </a:extLst>
          </p:cNvPr>
          <p:cNvSpPr txBox="1"/>
          <p:nvPr/>
        </p:nvSpPr>
        <p:spPr>
          <a:xfrm>
            <a:off x="214766" y="298461"/>
            <a:ext cx="2562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E5E88D9-1027-4BC4-B6A3-B20942DB3A4D}"/>
              </a:ext>
            </a:extLst>
          </p:cNvPr>
          <p:cNvSpPr txBox="1"/>
          <p:nvPr/>
        </p:nvSpPr>
        <p:spPr>
          <a:xfrm>
            <a:off x="3502473" y="314787"/>
            <a:ext cx="2562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B774BC7-4578-4EE6-B93B-29E74B3D7C6E}"/>
              </a:ext>
            </a:extLst>
          </p:cNvPr>
          <p:cNvSpPr txBox="1"/>
          <p:nvPr/>
        </p:nvSpPr>
        <p:spPr>
          <a:xfrm>
            <a:off x="170322" y="7911629"/>
            <a:ext cx="6517355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2. Systemic changes WT and </a:t>
            </a:r>
            <a:r>
              <a:rPr lang="en-US" sz="1100" b="1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gg1</a:t>
            </a:r>
            <a:r>
              <a:rPr lang="en-US" sz="1100" b="1" i="1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/- 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in 10 months after pristane. (A-C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 serum level of total IgG, IgG2a and IgG1 by ELISA. 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he level of anti-SSA auto antibody in serum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n=6-8 per group in duplicates. </a:t>
            </a:r>
            <a:r>
              <a:rPr lang="en-US" sz="11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ll data represent mean ± SD. Statistical significance was determined using Two-Way ANOVA with Bonferroni post-hoc test . *p&lt;0.05, **p&lt;0.01, ***p&lt;0.001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5BC20CD-95A4-FA47-8672-F4E4DFD53116}"/>
              </a:ext>
            </a:extLst>
          </p:cNvPr>
          <p:cNvSpPr txBox="1"/>
          <p:nvPr/>
        </p:nvSpPr>
        <p:spPr>
          <a:xfrm>
            <a:off x="214766" y="3182545"/>
            <a:ext cx="2562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DC15926-106B-7940-9CAB-0F9C25954ED2}"/>
              </a:ext>
            </a:extLst>
          </p:cNvPr>
          <p:cNvSpPr txBox="1"/>
          <p:nvPr/>
        </p:nvSpPr>
        <p:spPr>
          <a:xfrm>
            <a:off x="3489518" y="3080945"/>
            <a:ext cx="2692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6169C60-E7C4-7946-B995-DFCBD6D455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322" y="652689"/>
            <a:ext cx="3092823" cy="2286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1D07899-02D9-7E47-94E8-0BB6681205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8999" y="606969"/>
            <a:ext cx="3233768" cy="237744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56D3F09-8C51-8948-BC62-7608B62F72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4769" y="3547150"/>
            <a:ext cx="3162749" cy="219456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B4C4C51-E725-2040-B0E0-3EF15838F6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8999" y="3534830"/>
            <a:ext cx="3085106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69762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BC18F28E-7BA8-0043-B8AE-A1E53A674D8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599" y="1471589"/>
            <a:ext cx="3200400" cy="2103120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907CBE31-C1C9-45D6-8DBD-F4EC8202B225}"/>
              </a:ext>
            </a:extLst>
          </p:cNvPr>
          <p:cNvSpPr txBox="1"/>
          <p:nvPr/>
        </p:nvSpPr>
        <p:spPr>
          <a:xfrm>
            <a:off x="334494" y="1158779"/>
            <a:ext cx="2562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36BBDEB-5316-45DB-A568-520F62B959D3}"/>
              </a:ext>
            </a:extLst>
          </p:cNvPr>
          <p:cNvSpPr txBox="1"/>
          <p:nvPr/>
        </p:nvSpPr>
        <p:spPr>
          <a:xfrm>
            <a:off x="3359211" y="1095773"/>
            <a:ext cx="2562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329669B-8719-4C80-8879-CFE5BEBD8D03}"/>
              </a:ext>
            </a:extLst>
          </p:cNvPr>
          <p:cNvSpPr txBox="1"/>
          <p:nvPr/>
        </p:nvSpPr>
        <p:spPr>
          <a:xfrm>
            <a:off x="334494" y="3509536"/>
            <a:ext cx="2562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CD943BA-C805-43A7-B33F-1BF8415F7E25}"/>
              </a:ext>
            </a:extLst>
          </p:cNvPr>
          <p:cNvSpPr txBox="1"/>
          <p:nvPr/>
        </p:nvSpPr>
        <p:spPr>
          <a:xfrm>
            <a:off x="0" y="7596988"/>
            <a:ext cx="6857999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3. Pathological changes in kidney in 10 months after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pristane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. ( A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oteinuria measured by dipstick test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 B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eposition of IgG in glomeruli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Quantification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lomer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amage by index of pathology in glomeruli mesangial expansion/ hypercellularity (M.E.) and endocapillary hypercellularity (H.E.).</a:t>
            </a:r>
            <a:r>
              <a:rPr lang="en-US" dirty="0"/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=12-15 per group.  Statistic significant were determined by Mann-Whitney test.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E3D25F9-5530-9E4E-97B7-EB54948BAA4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05565" y="1512227"/>
            <a:ext cx="2917941" cy="210312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64A3301-66AE-AA4A-A8C0-37D27734A3C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8579" y="4094480"/>
            <a:ext cx="3020440" cy="210312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1AB5F85-F5C6-B647-8931-92DC0510AB8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28999" y="4094480"/>
            <a:ext cx="3020440" cy="2103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78209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75E46F4E-2F3F-3E4A-9B9B-9371C4A8F635}"/>
              </a:ext>
            </a:extLst>
          </p:cNvPr>
          <p:cNvGrpSpPr/>
          <p:nvPr/>
        </p:nvGrpSpPr>
        <p:grpSpPr>
          <a:xfrm>
            <a:off x="762000" y="1295400"/>
            <a:ext cx="5410200" cy="1948015"/>
            <a:chOff x="762000" y="1295400"/>
            <a:chExt cx="5410200" cy="1948015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79520A36-97AE-4D49-AABB-AC0D37B726A1}"/>
                </a:ext>
              </a:extLst>
            </p:cNvPr>
            <p:cNvSpPr txBox="1"/>
            <p:nvPr/>
          </p:nvSpPr>
          <p:spPr>
            <a:xfrm>
              <a:off x="838200" y="1295400"/>
              <a:ext cx="2000251" cy="3002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351" dirty="0"/>
                <a:t>Naïve Ogg1</a:t>
              </a:r>
            </a:p>
          </p:txBody>
        </p:sp>
        <p:pic>
          <p:nvPicPr>
            <p:cNvPr id="4" name="Picture 3" descr="A cat that is looking at the camera&#10;&#10;Description automatically generated">
              <a:extLst>
                <a:ext uri="{FF2B5EF4-FFF2-40B4-BE49-F238E27FC236}">
                  <a16:creationId xmlns:a16="http://schemas.microsoft.com/office/drawing/2014/main" id="{02C3D87B-FBFC-2F4E-9EE4-06587B4FF2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15946" t="13333" r="9588"/>
            <a:stretch/>
          </p:blipFill>
          <p:spPr>
            <a:xfrm>
              <a:off x="4062043" y="1765123"/>
              <a:ext cx="1033135" cy="99522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" name="Picture 4" descr="A cat sitting on a black surface&#10;&#10;Description automatically generated">
              <a:extLst>
                <a:ext uri="{FF2B5EF4-FFF2-40B4-BE49-F238E27FC236}">
                  <a16:creationId xmlns:a16="http://schemas.microsoft.com/office/drawing/2014/main" id="{943CC118-9B63-814E-96C8-F97C92327F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39000" contrast="23000"/>
                      </a14:imgEffect>
                    </a14:imgLayer>
                  </a14:imgProps>
                </a:ext>
              </a:extLst>
            </a:blip>
            <a:srcRect l="2107" t="12928" r="1836" b="1898"/>
            <a:stretch/>
          </p:blipFill>
          <p:spPr>
            <a:xfrm>
              <a:off x="2971800" y="1765124"/>
              <a:ext cx="1033134" cy="995222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" name="Picture 5" descr="A rodent looking at the camera&#10;&#10;Description automatically generated">
              <a:extLst>
                <a:ext uri="{FF2B5EF4-FFF2-40B4-BE49-F238E27FC236}">
                  <a16:creationId xmlns:a16="http://schemas.microsoft.com/office/drawing/2014/main" id="{5CE3FD43-B29A-4944-A9AF-165F1CA4C5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-3000"/>
                      </a14:imgEffect>
                      <a14:imgEffect>
                        <a14:brightnessContrast bright="50000"/>
                      </a14:imgEffect>
                    </a14:imgLayer>
                  </a14:imgProps>
                </a:ext>
              </a:extLst>
            </a:blip>
            <a:srcRect l="12093" t="17075" r="12093"/>
            <a:stretch/>
          </p:blipFill>
          <p:spPr>
            <a:xfrm>
              <a:off x="777926" y="1765124"/>
              <a:ext cx="1033136" cy="995223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" name="Picture 6" descr="A rodent looking at the camera&#10;&#10;Description automatically generated">
              <a:extLst>
                <a:ext uri="{FF2B5EF4-FFF2-40B4-BE49-F238E27FC236}">
                  <a16:creationId xmlns:a16="http://schemas.microsoft.com/office/drawing/2014/main" id="{BD21440D-3BBF-6540-B0CB-1C90AD9BF3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35000" contrast="30000"/>
                      </a14:imgEffect>
                    </a14:imgLayer>
                  </a14:imgProps>
                </a:ext>
              </a:extLst>
            </a:blip>
            <a:srcRect l="15867" t="12929" r="13568"/>
            <a:stretch/>
          </p:blipFill>
          <p:spPr>
            <a:xfrm>
              <a:off x="1874863" y="1765123"/>
              <a:ext cx="1033135" cy="995223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</p:pic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903309DE-5493-FB40-B4A4-BA88120069AB}"/>
                </a:ext>
              </a:extLst>
            </p:cNvPr>
            <p:cNvGrpSpPr/>
            <p:nvPr/>
          </p:nvGrpSpPr>
          <p:grpSpPr>
            <a:xfrm>
              <a:off x="5152288" y="1765124"/>
              <a:ext cx="999468" cy="995222"/>
              <a:chOff x="5123138" y="1765125"/>
              <a:chExt cx="999468" cy="995222"/>
            </a:xfrm>
          </p:grpSpPr>
          <p:pic>
            <p:nvPicPr>
              <p:cNvPr id="16" name="Picture 15" descr="A black cat with its mouth open&#10;&#10;Description automatically generated">
                <a:extLst>
                  <a:ext uri="{FF2B5EF4-FFF2-40B4-BE49-F238E27FC236}">
                    <a16:creationId xmlns:a16="http://schemas.microsoft.com/office/drawing/2014/main" id="{F7F8B2A8-3834-5147-801E-19F3E090A66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20000" contrast="14000"/>
                        </a14:imgEffect>
                      </a14:imgLayer>
                    </a14:imgProps>
                  </a:ext>
                </a:extLst>
              </a:blip>
              <a:srcRect l="7346" r="5846"/>
              <a:stretch/>
            </p:blipFill>
            <p:spPr>
              <a:xfrm>
                <a:off x="5123138" y="1765125"/>
                <a:ext cx="999468" cy="995222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7" name="Picture 16" descr="A black cat with its mouth open&#10;&#10;Description automatically generated">
                <a:extLst>
                  <a:ext uri="{FF2B5EF4-FFF2-40B4-BE49-F238E27FC236}">
                    <a16:creationId xmlns:a16="http://schemas.microsoft.com/office/drawing/2014/main" id="{036F83C0-F358-2A45-9F53-F8D410DE00E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rcRect l="73529" r="5846" b="84615"/>
              <a:stretch/>
            </p:blipFill>
            <p:spPr>
              <a:xfrm>
                <a:off x="5123138" y="1792833"/>
                <a:ext cx="242217" cy="155448"/>
              </a:xfrm>
              <a:prstGeom prst="rect">
                <a:avLst/>
              </a:prstGeom>
              <a:ln w="3175">
                <a:noFill/>
              </a:ln>
            </p:spPr>
          </p:pic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CB9268C-A5B4-A748-92A9-802CC60F64CD}"/>
                </a:ext>
              </a:extLst>
            </p:cNvPr>
            <p:cNvSpPr txBox="1"/>
            <p:nvPr/>
          </p:nvSpPr>
          <p:spPr>
            <a:xfrm>
              <a:off x="4528414" y="2765617"/>
              <a:ext cx="1197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85777B2-6560-A740-88E4-63B79049F7EE}"/>
                </a:ext>
              </a:extLst>
            </p:cNvPr>
            <p:cNvSpPr txBox="1"/>
            <p:nvPr/>
          </p:nvSpPr>
          <p:spPr>
            <a:xfrm>
              <a:off x="1219200" y="2580951"/>
              <a:ext cx="37636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  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2C31C02-35A8-C74C-A24C-87408B3B7D26}"/>
                </a:ext>
              </a:extLst>
            </p:cNvPr>
            <p:cNvSpPr txBox="1"/>
            <p:nvPr/>
          </p:nvSpPr>
          <p:spPr>
            <a:xfrm>
              <a:off x="2318614" y="2765617"/>
              <a:ext cx="1197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296FB2B0-01A4-064C-82D9-E2A77F748D52}"/>
                </a:ext>
              </a:extLst>
            </p:cNvPr>
            <p:cNvCxnSpPr>
              <a:cxnSpLocks/>
            </p:cNvCxnSpPr>
            <p:nvPr/>
          </p:nvCxnSpPr>
          <p:spPr>
            <a:xfrm>
              <a:off x="762000" y="2971800"/>
              <a:ext cx="54102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B31A6F6-247E-E846-B1E6-62BF4D2DE924}"/>
                </a:ext>
              </a:extLst>
            </p:cNvPr>
            <p:cNvSpPr txBox="1"/>
            <p:nvPr/>
          </p:nvSpPr>
          <p:spPr>
            <a:xfrm>
              <a:off x="2743200" y="2966416"/>
              <a:ext cx="14940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ge ( month)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6DBA5DA-FADC-3B41-A5E7-51715CCF1723}"/>
                </a:ext>
              </a:extLst>
            </p:cNvPr>
            <p:cNvSpPr txBox="1"/>
            <p:nvPr/>
          </p:nvSpPr>
          <p:spPr>
            <a:xfrm>
              <a:off x="3385414" y="2765617"/>
              <a:ext cx="11978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8B65731-3AF1-7043-9434-2643678247DF}"/>
                </a:ext>
              </a:extLst>
            </p:cNvPr>
            <p:cNvSpPr txBox="1"/>
            <p:nvPr/>
          </p:nvSpPr>
          <p:spPr>
            <a:xfrm>
              <a:off x="5562600" y="2771001"/>
              <a:ext cx="381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D4550863-256F-E048-AF9F-81E087B12D4D}"/>
              </a:ext>
            </a:extLst>
          </p:cNvPr>
          <p:cNvSpPr txBox="1"/>
          <p:nvPr/>
        </p:nvSpPr>
        <p:spPr>
          <a:xfrm>
            <a:off x="589085" y="65063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8C10731D-758D-E343-8692-1CF1BCAF37A6}"/>
              </a:ext>
            </a:extLst>
          </p:cNvPr>
          <p:cNvSpPr/>
          <p:nvPr/>
        </p:nvSpPr>
        <p:spPr>
          <a:xfrm>
            <a:off x="511640" y="7473241"/>
            <a:ext cx="595345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/>
              <a:t>Representative pictures of hair loss pattern observed in naïve Ogg1 KO mice. </a:t>
            </a:r>
            <a:r>
              <a:rPr lang="en-US" sz="1200" dirty="0"/>
              <a:t>The area of hair loss mainly restricted in dorsal neck and regrowth occurred and thinning hair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86198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5E2B1B29-80B5-0242-85CC-13CC8B580DE0}"/>
              </a:ext>
            </a:extLst>
          </p:cNvPr>
          <p:cNvSpPr/>
          <p:nvPr/>
        </p:nvSpPr>
        <p:spPr>
          <a:xfrm>
            <a:off x="355548" y="5101122"/>
            <a:ext cx="6146904" cy="9848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Figure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5.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TING inhibition is not involved  in Poly IC induced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Ifnb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he expression of </a:t>
            </a:r>
            <a:r>
              <a:rPr lang="en-US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Ifn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RNA in BMDM from WT mice, were stimulated with Poly IC  with or without H151 (STING inhibitor). n=5-6 per group. All data represent mean ± SD. Statistical significance was determined using Two-way ANOVA with Bonferroni post-hoc test. ***p&lt;0.001</a:t>
            </a:r>
            <a:r>
              <a:rPr lang="en-US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.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E78491A-8C48-574F-B615-2FD5F4EBED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9916" y="1869017"/>
            <a:ext cx="3009900" cy="2476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95158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45</TotalTime>
  <Words>408</Words>
  <Application>Microsoft Macintosh PowerPoint</Application>
  <PresentationFormat>Custom</PresentationFormat>
  <Paragraphs>27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eries, Caroline</dc:creator>
  <cp:lastModifiedBy>Chen, Shuang</cp:lastModifiedBy>
  <cp:revision>199</cp:revision>
  <cp:lastPrinted>2020-04-09T19:22:53Z</cp:lastPrinted>
  <dcterms:created xsi:type="dcterms:W3CDTF">2019-03-28T19:56:47Z</dcterms:created>
  <dcterms:modified xsi:type="dcterms:W3CDTF">2020-07-23T18:32:18Z</dcterms:modified>
</cp:coreProperties>
</file>